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02474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41851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09458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90625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10970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90021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54094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16372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57907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12167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76033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1FB45F-596F-4FDB-BC7F-5FFD1C4B0DC0}" type="datetimeFigureOut">
              <a:rPr lang="el-GR" smtClean="0"/>
              <a:t>13/3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2869C-8EED-4FD7-8C6F-F79ADF0B707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13851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4341" r="25093"/>
          <a:stretch/>
        </p:blipFill>
        <p:spPr>
          <a:xfrm>
            <a:off x="2028825" y="1237128"/>
            <a:ext cx="6093199" cy="459217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903431" y="3663466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K-19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+)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232055" y="2977561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K-19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006419" y="1543650"/>
            <a:ext cx="198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 0.046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411" y="188259"/>
            <a:ext cx="1801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A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8100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7703" r="25423"/>
          <a:stretch/>
        </p:blipFill>
        <p:spPr>
          <a:xfrm>
            <a:off x="2028825" y="1398494"/>
            <a:ext cx="6066304" cy="443080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238252" y="3390978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4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CD2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-)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238252" y="4645120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4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CD2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+)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060474" y="1304364"/>
            <a:ext cx="198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 0.005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411" y="188259"/>
            <a:ext cx="1801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B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45888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r="25423"/>
          <a:stretch/>
        </p:blipFill>
        <p:spPr>
          <a:xfrm>
            <a:off x="2028825" y="1028700"/>
            <a:ext cx="6066304" cy="4800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138388" y="3046757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DH1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CD2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-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300829" y="4570499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DH1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CD24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+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296765" y="1476849"/>
            <a:ext cx="198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02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411" y="188259"/>
            <a:ext cx="1801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C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02604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4062" r="25258"/>
          <a:stretch/>
        </p:blipFill>
        <p:spPr>
          <a:xfrm>
            <a:off x="2028825" y="1223682"/>
            <a:ext cx="6079751" cy="460561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344959" y="2996334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  <a:r>
              <a:rPr lang="en-US" sz="1500" b="1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239929" y="4046231"/>
            <a:ext cx="376361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 (+)</a:t>
            </a:r>
            <a:endParaRPr lang="el-GR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381127" y="1533330"/>
            <a:ext cx="198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30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411" y="188259"/>
            <a:ext cx="1801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D</a:t>
            </a:r>
            <a:endParaRPr lang="el-G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1418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36</Words>
  <Application>Microsoft Office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eti Strati</dc:creator>
  <cp:lastModifiedBy>Areti Strati</cp:lastModifiedBy>
  <cp:revision>5</cp:revision>
  <dcterms:created xsi:type="dcterms:W3CDTF">2021-03-07T20:31:20Z</dcterms:created>
  <dcterms:modified xsi:type="dcterms:W3CDTF">2021-03-13T11:33:38Z</dcterms:modified>
</cp:coreProperties>
</file>